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687F6-4C6B-6369-9EE3-747B93623D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904C71-9921-0489-FE68-2F58FA0D01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F3E8C-3EA7-0B6E-11CB-78578150F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34C5A-320A-BA9D-78B6-FFA78DFF8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83971-9224-1610-582B-BB2B51D04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3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59418-D4DC-BCF2-A1CC-040ECDB70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D0B398-E485-2DF5-C572-CDEF2930F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57D59-31AD-4200-2C0C-59479213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9A3DC-0E36-FF43-6198-26D49E262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4A69C-21E0-8CF5-2E64-442D39719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919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EBBB4B-109F-25E7-C7A1-23051AE2B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1FEC02-CA38-FA35-3708-AAECE4F5C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3AE3B-DB34-D978-8009-F0EB6FA10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BD705-7121-EE04-F395-B70EA1E4E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30317-9FFE-B3AD-6C3D-DDFDECF28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602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8BE75-D11A-A224-8861-1CDC372C9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04CB8-9C26-6640-5EEE-15381F78C9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3284C-9249-A367-4758-3F919E65D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0BE36-C7C7-2F19-548E-18227B183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31BE9-E0EB-A0BC-FEE7-F21863842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30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1F13E-7C44-81FB-0AEC-B1B685F45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E53FE-2ADC-CF38-F440-B50B57B912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14535-4E3C-2531-DA9F-2646B1693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3C9E8-28E2-87D4-DE51-FC8FD67D0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26FAE-4E8F-6D08-2C19-A541B685A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68851-6D8F-0F18-5717-A32E082CF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062C8-43E5-D7F5-6B38-D64977278C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4E019-4E04-F969-8C1C-A8260C1E1D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EB8D5-07EE-963B-D2DF-6672DDF34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683DE-C2D7-17BC-F470-DD05D38BA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2302EA-1035-F103-84CA-471C3AE76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428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61BA1-9DBF-BAE2-745D-6098E0045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3DC1B7-A74B-4F72-5BD4-D91956B01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A0DD8-0C79-011C-26CA-A09176E6B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7EB3F4-A6D3-9682-17FD-A0BB211A9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F2FFC7-301B-ACC2-E973-5B24523CE8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FFC61A-0E54-C0A9-C5F1-D1F260AF3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E1CE56-23B4-F3EB-1781-23F13B990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923681-7EE1-8BC6-C311-AB637D565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300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8C014-E56F-1C4F-28A6-90AF332D0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EC019-E8FA-928D-6E8A-17A5D9775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D10046-BC6F-CBFD-3F93-937392AEA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2DB107-6695-7300-0FDF-E89754411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9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BFDAF1-9914-E937-8469-4E2F1ED3F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A9CC04-AAC2-B939-5A52-5D2926A74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6231AC-B92E-35B3-0EAF-23C62DAC0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7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02618-FBF5-05D7-D0EA-FA3B7EE80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E2876-AD8D-136A-79AE-5F18D66FB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86F49-3275-1039-77E9-1A626663E0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4747B-DA38-16EE-8A25-F1ECFD821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45AC54-B0D0-AF2B-DCB5-BC831A09D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3C102-311D-F2F6-FC04-39D123884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530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BA4ED-F74E-D1DE-B740-6022A7DB7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49B25D-FA06-7627-2E2B-94D4657312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74699-2556-3095-12CC-C0660D7B92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69598D-A7D9-1364-2E85-E643EA7F3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34205-E51D-D7B9-19B6-DA3E6C794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30C37-E7EC-7457-3E7F-9ED4E94F8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946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33A064-A5CF-58A4-0258-5353D75B8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CD9D3-112C-2181-515B-9932AFE60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50A63-E4EE-CD8D-73FC-2E9EE9E871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2543F3-53F0-403F-AAF1-95F0222D8B5D}" type="datetimeFigureOut">
              <a:rPr lang="en-GB" smtClean="0"/>
              <a:t>06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0D9E3-209F-D263-FCD0-93420C0BB1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E218F-96D0-FA11-DFF1-6248769D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604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F70A8C6-3CE4-EABA-204F-CCC9A7F66EF9}"/>
              </a:ext>
            </a:extLst>
          </p:cNvPr>
          <p:cNvSpPr txBox="1"/>
          <p:nvPr/>
        </p:nvSpPr>
        <p:spPr>
          <a:xfrm>
            <a:off x="1809193" y="5752588"/>
            <a:ext cx="8592661" cy="718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5. Comparison of pH changes according to dietary fibre substrate and the presence of omega-3 PUFAs (1-50 </a:t>
            </a:r>
            <a:r>
              <a:rPr lang="en-GB" sz="1200" b="1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/mL).</a:t>
            </a: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ta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re the mean and standard deviation (bars). n=10 for all experimental conditions except for n=9 for 1 </a:t>
            </a:r>
            <a:r>
              <a:rPr lang="en-GB" sz="1200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</a:rPr>
              <a:t>g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/ml and 50 </a:t>
            </a:r>
            <a:r>
              <a:rPr lang="en-GB" sz="1200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/ml omega-3 PUFAs </a:t>
            </a:r>
            <a:r>
              <a:rPr lang="en-GB" sz="120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(O3FAs) with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ectin.</a:t>
            </a:r>
            <a:endParaRPr lang="en-GB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B337977-D065-13FE-5ABE-0B7BC1E4AE1C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8181" y="352425"/>
            <a:ext cx="9554687" cy="5191125"/>
          </a:xfrm>
          <a:prstGeom prst="rect">
            <a:avLst/>
          </a:prstGeom>
          <a:noFill/>
          <a:ln w="9525" cmpd="sng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59644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6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k Hull</dc:creator>
  <cp:lastModifiedBy>Mark Hull</cp:lastModifiedBy>
  <cp:revision>7</cp:revision>
  <dcterms:created xsi:type="dcterms:W3CDTF">2024-10-08T08:08:35Z</dcterms:created>
  <dcterms:modified xsi:type="dcterms:W3CDTF">2024-11-06T12:57:09Z</dcterms:modified>
</cp:coreProperties>
</file>